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216" r:id="rId1"/>
  </p:sldMasterIdLst>
  <p:notesMasterIdLst>
    <p:notesMasterId r:id="rId11"/>
  </p:notesMasterIdLst>
  <p:sldIdLst>
    <p:sldId id="965" r:id="rId2"/>
    <p:sldId id="966" r:id="rId3"/>
    <p:sldId id="919" r:id="rId4"/>
    <p:sldId id="950" r:id="rId5"/>
    <p:sldId id="934" r:id="rId6"/>
    <p:sldId id="968" r:id="rId7"/>
    <p:sldId id="967" r:id="rId8"/>
    <p:sldId id="955" r:id="rId9"/>
    <p:sldId id="926" r:id="rId10"/>
  </p:sldIdLst>
  <p:sldSz cx="9144000" cy="6858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annan R" initials="K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CC4"/>
    <a:srgbClr val="CCD5EA"/>
    <a:srgbClr val="E7EBF5"/>
    <a:srgbClr val="FFE285"/>
    <a:srgbClr val="C5FFD7"/>
    <a:srgbClr val="FFE07D"/>
    <a:srgbClr val="FFDE75"/>
    <a:srgbClr val="0070C0"/>
    <a:srgbClr val="422100"/>
    <a:srgbClr val="663300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125E5076-3810-47DD-B79F-674D7AD40C01}" styleName="Dark Style 1 - Accent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0294" autoAdjust="0"/>
    <p:restoredTop sz="88989" autoAdjust="0"/>
  </p:normalViewPr>
  <p:slideViewPr>
    <p:cSldViewPr>
      <p:cViewPr varScale="1">
        <p:scale>
          <a:sx n="73" d="100"/>
          <a:sy n="73" d="100"/>
        </p:scale>
        <p:origin x="-1794" y="-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170138" cy="479539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427" y="0"/>
            <a:ext cx="3170138" cy="479539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pPr>
              <a:defRPr/>
            </a:pPr>
            <a:fld id="{29B334CF-CDB4-4742-B2C3-8D76D9E0F1BE}" type="datetimeFigureOut">
              <a:rPr lang="en-US"/>
              <a:pPr>
                <a:defRPr/>
              </a:pPr>
              <a:t>1/4/201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58888" y="720725"/>
            <a:ext cx="4797425" cy="3598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194" y="4560086"/>
            <a:ext cx="5852814" cy="4320317"/>
          </a:xfrm>
          <a:prstGeom prst="rect">
            <a:avLst/>
          </a:prstGeom>
        </p:spPr>
        <p:txBody>
          <a:bodyPr vert="horz" lIns="99048" tIns="49524" rIns="99048" bIns="49524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120172"/>
            <a:ext cx="3170138" cy="479539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427" y="9120172"/>
            <a:ext cx="3170138" cy="479539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pPr>
              <a:defRPr/>
            </a:pPr>
            <a:fld id="{23B267FD-77FE-4925-9387-1ACF7D24F99A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="" xmlns:p14="http://schemas.microsoft.com/office/powerpoint/2010/main" val="7069317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Welcome.png"/>
          <p:cNvPicPr/>
          <p:nvPr userDrawn="1"/>
        </p:nvPicPr>
        <p:blipFill>
          <a:blip r:embed="rId2" cstate="print">
            <a:extLst/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  <a:ln>
            <a:round/>
          </a:ln>
        </p:spPr>
      </p:pic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Shape 32"/>
          <p:cNvSpPr>
            <a:spLocks noGrp="1"/>
          </p:cNvSpPr>
          <p:nvPr>
            <p:ph type="body" idx="1"/>
          </p:nvPr>
        </p:nvSpPr>
        <p:spPr>
          <a:xfrm>
            <a:off x="892969" y="892969"/>
            <a:ext cx="7349133" cy="5063133"/>
          </a:xfrm>
          <a:prstGeom prst="rect">
            <a:avLst/>
          </a:prstGeom>
        </p:spPr>
        <p:txBody>
          <a:bodyPr lIns="35717" tIns="35717" rIns="35717" bIns="35717" anchor="ctr"/>
          <a:lstStyle>
            <a:lvl1pPr marL="625056" marR="0" indent="-401822" defTabSz="410751">
              <a:spcBef>
                <a:spcPts val="3375"/>
              </a:spcBef>
              <a:buSzPct val="171000"/>
              <a:defRPr sz="2700">
                <a:uFillTx/>
                <a:latin typeface="+mn-lt"/>
                <a:ea typeface="+mn-ea"/>
                <a:cs typeface="+mn-cs"/>
                <a:sym typeface="Gill Sans"/>
              </a:defRPr>
            </a:lvl1pPr>
            <a:lvl2pPr marL="937584" marR="0" indent="-401822" defTabSz="410751">
              <a:spcBef>
                <a:spcPts val="3375"/>
              </a:spcBef>
              <a:buSzPct val="171000"/>
              <a:defRPr sz="2700">
                <a:uFillTx/>
                <a:latin typeface="+mn-lt"/>
                <a:ea typeface="+mn-ea"/>
                <a:cs typeface="+mn-cs"/>
                <a:sym typeface="Gill Sans"/>
              </a:defRPr>
            </a:lvl2pPr>
            <a:lvl3pPr marL="1250112" marR="0" indent="-401822" defTabSz="410751">
              <a:spcBef>
                <a:spcPts val="3375"/>
              </a:spcBef>
              <a:buSzPct val="171000"/>
              <a:defRPr sz="2700">
                <a:uFillTx/>
                <a:latin typeface="+mn-lt"/>
                <a:ea typeface="+mn-ea"/>
                <a:cs typeface="+mn-cs"/>
                <a:sym typeface="Gill Sans"/>
              </a:defRPr>
            </a:lvl3pPr>
            <a:lvl4pPr marL="1562640" marR="0" indent="-401822" defTabSz="410751">
              <a:spcBef>
                <a:spcPts val="3375"/>
              </a:spcBef>
              <a:buSzPct val="171000"/>
              <a:defRPr sz="2700">
                <a:uFillTx/>
                <a:latin typeface="+mn-lt"/>
                <a:ea typeface="+mn-ea"/>
                <a:cs typeface="+mn-cs"/>
                <a:sym typeface="Gill Sans"/>
              </a:defRPr>
            </a:lvl4pPr>
            <a:lvl5pPr marL="1875168" marR="0" indent="-401822" defTabSz="410751">
              <a:spcBef>
                <a:spcPts val="3375"/>
              </a:spcBef>
              <a:buSzPct val="171000"/>
              <a:defRPr sz="2700">
                <a:uFillTx/>
                <a:latin typeface="+mn-lt"/>
                <a:ea typeface="+mn-ea"/>
                <a:cs typeface="+mn-cs"/>
                <a:sym typeface="Gill Sans"/>
              </a:defRPr>
            </a:lvl5pPr>
          </a:lstStyle>
          <a:p>
            <a:pPr lvl="0">
              <a:defRPr sz="1800"/>
            </a:pPr>
            <a:r>
              <a:rPr sz="3800"/>
              <a:t>Body Level One</a:t>
            </a:r>
          </a:p>
          <a:p>
            <a:pPr lvl="1">
              <a:defRPr sz="1800"/>
            </a:pPr>
            <a:r>
              <a:rPr sz="3800"/>
              <a:t>Body Level Two</a:t>
            </a:r>
          </a:p>
          <a:p>
            <a:pPr lvl="2">
              <a:defRPr sz="1800"/>
            </a:pPr>
            <a:r>
              <a:rPr sz="3800"/>
              <a:t>Body Level Three</a:t>
            </a:r>
          </a:p>
          <a:p>
            <a:pPr lvl="3">
              <a:defRPr sz="1800"/>
            </a:pPr>
            <a:r>
              <a:rPr sz="3800"/>
              <a:t>Body Level Four</a:t>
            </a:r>
          </a:p>
          <a:p>
            <a:pPr lvl="4">
              <a:defRPr sz="1800"/>
            </a:pPr>
            <a:r>
              <a:rPr sz="38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"/>
          <p:cNvSpPr>
            <a:spLocks noGrp="1"/>
          </p:cNvSpPr>
          <p:nvPr>
            <p:ph type="title"/>
          </p:nvPr>
        </p:nvSpPr>
        <p:spPr>
          <a:xfrm>
            <a:off x="990600" y="2362200"/>
            <a:ext cx="5486400" cy="563562"/>
          </a:xfrm>
        </p:spPr>
        <p:txBody>
          <a:bodyPr/>
          <a:lstStyle>
            <a:lvl1pPr>
              <a:defRPr sz="3200" baseline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5" name="Date Placeholder 4"/>
          <p:cNvSpPr>
            <a:spLocks noGrp="1" noChangeArrowheads="1"/>
          </p:cNvSpPr>
          <p:nvPr>
            <p:ph type="dt" sz="half" idx="10"/>
          </p:nvPr>
        </p:nvSpPr>
        <p:spPr>
          <a:xfrm>
            <a:off x="457200" y="6477000"/>
            <a:ext cx="2133600" cy="24447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Footer Placeholder 5"/>
          <p:cNvSpPr>
            <a:spLocks noGrp="1" noChangeArrowheads="1"/>
          </p:cNvSpPr>
          <p:nvPr>
            <p:ph type="ftr" sz="quarter" idx="11"/>
          </p:nvPr>
        </p:nvSpPr>
        <p:spPr>
          <a:xfrm>
            <a:off x="3124200" y="6477000"/>
            <a:ext cx="2895600" cy="244475"/>
          </a:xfrm>
          <a:prstGeom prst="rect">
            <a:avLst/>
          </a:prstGeom>
        </p:spPr>
        <p:txBody>
          <a:bodyPr/>
          <a:lstStyle>
            <a:lvl1pPr algn="ctr">
              <a:defRPr b="0">
                <a:solidFill>
                  <a:schemeClr val="tx1"/>
                </a:solidFill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6553200" y="6477000"/>
            <a:ext cx="2133600" cy="24447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fld id="{C335A9A4-4DB5-4F3A-8546-625F1799703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pic>
        <p:nvPicPr>
          <p:cNvPr id="44033" name="Picture 1" descr="C:\Users\Tarun Romale\Desktop\deTAB logo.png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277225" y="38100"/>
            <a:ext cx="790575" cy="7239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"/>
          <p:cNvSpPr>
            <a:spLocks noGrp="1"/>
          </p:cNvSpPr>
          <p:nvPr>
            <p:ph type="title"/>
          </p:nvPr>
        </p:nvSpPr>
        <p:spPr>
          <a:xfrm>
            <a:off x="990600" y="2362200"/>
            <a:ext cx="5486400" cy="563562"/>
          </a:xfrm>
        </p:spPr>
        <p:txBody>
          <a:bodyPr/>
          <a:lstStyle>
            <a:lvl1pPr>
              <a:defRPr sz="3200" baseline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5" name="Date Placeholder 4"/>
          <p:cNvSpPr>
            <a:spLocks noGrp="1" noChangeArrowheads="1"/>
          </p:cNvSpPr>
          <p:nvPr>
            <p:ph type="dt" sz="half" idx="10"/>
          </p:nvPr>
        </p:nvSpPr>
        <p:spPr>
          <a:xfrm>
            <a:off x="457200" y="6477000"/>
            <a:ext cx="2133600" cy="24447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Footer Placeholder 5"/>
          <p:cNvSpPr>
            <a:spLocks noGrp="1" noChangeArrowheads="1"/>
          </p:cNvSpPr>
          <p:nvPr>
            <p:ph type="ftr" sz="quarter" idx="11"/>
          </p:nvPr>
        </p:nvSpPr>
        <p:spPr>
          <a:xfrm>
            <a:off x="3124200" y="6477000"/>
            <a:ext cx="2895600" cy="244475"/>
          </a:xfrm>
          <a:prstGeom prst="rect">
            <a:avLst/>
          </a:prstGeom>
        </p:spPr>
        <p:txBody>
          <a:bodyPr/>
          <a:lstStyle>
            <a:lvl1pPr algn="ctr">
              <a:defRPr b="0">
                <a:solidFill>
                  <a:schemeClr val="tx1"/>
                </a:solidFill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6553200" y="6477000"/>
            <a:ext cx="2133600" cy="24447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fld id="{C335A9A4-4DB5-4F3A-8546-625F1799703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"/>
          <p:cNvSpPr>
            <a:spLocks noGrp="1"/>
          </p:cNvSpPr>
          <p:nvPr>
            <p:ph type="title"/>
          </p:nvPr>
        </p:nvSpPr>
        <p:spPr>
          <a:xfrm>
            <a:off x="990600" y="2362200"/>
            <a:ext cx="5486400" cy="563562"/>
          </a:xfrm>
        </p:spPr>
        <p:txBody>
          <a:bodyPr/>
          <a:lstStyle>
            <a:lvl1pPr>
              <a:defRPr sz="3200" baseline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5" name="Date Placeholder 4"/>
          <p:cNvSpPr>
            <a:spLocks noGrp="1" noChangeArrowheads="1"/>
          </p:cNvSpPr>
          <p:nvPr>
            <p:ph type="dt" sz="half" idx="10"/>
          </p:nvPr>
        </p:nvSpPr>
        <p:spPr>
          <a:xfrm>
            <a:off x="457200" y="6477000"/>
            <a:ext cx="2133600" cy="24447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Footer Placeholder 5"/>
          <p:cNvSpPr>
            <a:spLocks noGrp="1" noChangeArrowheads="1"/>
          </p:cNvSpPr>
          <p:nvPr>
            <p:ph type="ftr" sz="quarter" idx="11"/>
          </p:nvPr>
        </p:nvSpPr>
        <p:spPr>
          <a:xfrm>
            <a:off x="3124200" y="6477000"/>
            <a:ext cx="2895600" cy="244475"/>
          </a:xfrm>
          <a:prstGeom prst="rect">
            <a:avLst/>
          </a:prstGeom>
        </p:spPr>
        <p:txBody>
          <a:bodyPr/>
          <a:lstStyle>
            <a:lvl1pPr algn="ctr">
              <a:defRPr b="0">
                <a:solidFill>
                  <a:schemeClr val="tx1"/>
                </a:solidFill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6553200" y="6477000"/>
            <a:ext cx="2133600" cy="24447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fld id="{C335A9A4-4DB5-4F3A-8546-625F1799703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pic>
        <p:nvPicPr>
          <p:cNvPr id="44033" name="Picture 1" descr="C:\Users\Tarun Romale\Desktop\deTAB logo.png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277225" y="38100"/>
            <a:ext cx="790575" cy="7239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42395-4F3B-48F4-9478-55B6E7EB4146}" type="datetimeFigureOut">
              <a:rPr lang="en-US" smtClean="0"/>
              <a:pPr/>
              <a:t>1/4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DCF581-0B6C-4386-93D2-8B8675E00E96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217" r:id="rId1"/>
    <p:sldLayoutId id="2147484218" r:id="rId2"/>
    <p:sldLayoutId id="2147484219" r:id="rId3"/>
    <p:sldLayoutId id="2147484220" r:id="rId4"/>
    <p:sldLayoutId id="2147484221" r:id="rId5"/>
    <p:sldLayoutId id="2147484222" r:id="rId6"/>
    <p:sldLayoutId id="2147484223" r:id="rId7"/>
    <p:sldLayoutId id="2147484224" r:id="rId8"/>
    <p:sldLayoutId id="2147484225" r:id="rId9"/>
    <p:sldLayoutId id="2147484226" r:id="rId10"/>
    <p:sldLayoutId id="2147484227" r:id="rId11"/>
    <p:sldLayoutId id="2147484228" r:id="rId12"/>
    <p:sldLayoutId id="2147484202" r:id="rId13"/>
    <p:sldLayoutId id="2147484203" r:id="rId14"/>
    <p:sldLayoutId id="2147484204" r:id="rId15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965954203"/>
              </p:ext>
            </p:extLst>
          </p:nvPr>
        </p:nvGraphicFramePr>
        <p:xfrm>
          <a:off x="243840" y="457200"/>
          <a:ext cx="8747760" cy="6081585"/>
        </p:xfrm>
        <a:graphic>
          <a:graphicData uri="http://schemas.openxmlformats.org/drawingml/2006/table">
            <a:tbl>
              <a:tblPr firstRow="1" bandRow="1">
                <a:tableStyleId>{B301B821-A1FF-4177-AEE7-76D212191A09}</a:tableStyleId>
              </a:tblPr>
              <a:tblGrid>
                <a:gridCol w="1524000"/>
                <a:gridCol w="822960"/>
                <a:gridCol w="822960"/>
                <a:gridCol w="822960"/>
                <a:gridCol w="1005840"/>
                <a:gridCol w="914400"/>
                <a:gridCol w="914400"/>
                <a:gridCol w="1097280"/>
                <a:gridCol w="822960"/>
              </a:tblGrid>
              <a:tr h="457200">
                <a:tc gridSpan="9"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ysClr val="windowText" lastClr="000000"/>
                          </a:solidFill>
                          <a:cs typeface="Arial" pitchFamily="34" charset="0"/>
                        </a:rPr>
                        <a:t>Supplementary table 1</a:t>
                      </a:r>
                      <a:endParaRPr lang="en-US" sz="1200" dirty="0"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57200">
                <a:tc gridSpan="9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ysClr val="windowText" lastClr="000000"/>
                          </a:solidFill>
                          <a:cs typeface="Arial" pitchFamily="34" charset="0"/>
                        </a:rPr>
                        <a:t>Preferred aspect of CME activity between two CME activitie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edical Onc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Psychiatr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iabe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Rheu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er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Orthopaedics</a:t>
                      </a:r>
                      <a:endParaRPr kumimoji="0" lang="en-GB" sz="1200" b="1" i="0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europhysicia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en-GB" sz="1200" b="1" i="0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GP/FP</a:t>
                      </a:r>
                      <a:endParaRPr kumimoji="0" lang="en-GB" sz="1200" b="1" i="0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42498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latin typeface="+mj-lt"/>
                        </a:rPr>
                        <a:t>Self-learning vs. Instructor led </a:t>
                      </a:r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 smtClean="0">
                          <a:latin typeface="+mj-lt"/>
                        </a:rPr>
                        <a:t>self-learning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6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4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Instructor </a:t>
                      </a:r>
                      <a:r>
                        <a:rPr lang="en-GB" sz="1200" u="none" strike="noStrike" dirty="0" smtClean="0">
                          <a:latin typeface="+mj-lt"/>
                        </a:rPr>
                        <a:t>led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5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78423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Digital vs. Face to face 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Digital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1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Face to Face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7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8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78423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 smtClean="0">
                          <a:latin typeface="+mj-lt"/>
                        </a:rPr>
                        <a:t>Domestic location vs. International location</a:t>
                      </a:r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Domestic </a:t>
                      </a:r>
                      <a:r>
                        <a:rPr lang="en-GB" sz="1200" u="none" strike="noStrike" dirty="0" smtClean="0">
                          <a:latin typeface="+mj-lt"/>
                        </a:rPr>
                        <a:t>location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8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8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7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7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7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8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International </a:t>
                      </a:r>
                      <a:r>
                        <a:rPr lang="en-GB" sz="1200" u="none" strike="noStrike" dirty="0" smtClean="0">
                          <a:latin typeface="+mj-lt"/>
                        </a:rPr>
                        <a:t>location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2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78423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rint vs. digital 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Print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5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Digital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4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67673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latin typeface="+mj-lt"/>
                        </a:rPr>
                        <a:t>Indian speaker vs. Foreign speaker </a:t>
                      </a:r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Indian </a:t>
                      </a:r>
                      <a:r>
                        <a:rPr lang="en-GB" sz="1200" u="none" strike="noStrike" dirty="0" smtClean="0">
                          <a:latin typeface="+mj-lt"/>
                        </a:rPr>
                        <a:t>speaker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6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7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7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8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Foreign </a:t>
                      </a:r>
                      <a:r>
                        <a:rPr lang="en-GB" sz="1200" u="none" strike="noStrike" dirty="0" smtClean="0">
                          <a:latin typeface="+mj-lt"/>
                        </a:rPr>
                        <a:t>speaker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2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67673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 smtClean="0">
                          <a:latin typeface="+mj-lt"/>
                        </a:rPr>
                        <a:t>Residential vs. Non-residential </a:t>
                      </a:r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Residential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6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6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Non-residential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4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67673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latin typeface="+mj-lt"/>
                        </a:rPr>
                        <a:t>Credit points vs. Institute of repute </a:t>
                      </a:r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CME </a:t>
                      </a:r>
                      <a:r>
                        <a:rPr lang="en-GB" sz="1200" u="none" strike="noStrike" dirty="0" smtClean="0">
                          <a:latin typeface="+mj-lt"/>
                        </a:rPr>
                        <a:t>points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5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4249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u="none" strike="noStrike" dirty="0">
                          <a:latin typeface="+mj-lt"/>
                        </a:rPr>
                        <a:t>Institute of </a:t>
                      </a:r>
                      <a:r>
                        <a:rPr lang="en-GB" sz="1200" u="none" strike="noStrike" dirty="0" smtClean="0">
                          <a:latin typeface="+mj-lt"/>
                        </a:rPr>
                        <a:t>repute</a:t>
                      </a:r>
                      <a:endParaRPr lang="en-GB" sz="1200" b="0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4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517834299"/>
              </p:ext>
            </p:extLst>
          </p:nvPr>
        </p:nvGraphicFramePr>
        <p:xfrm>
          <a:off x="76200" y="533400"/>
          <a:ext cx="8991600" cy="575478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90800"/>
                <a:gridCol w="762000"/>
                <a:gridCol w="533400"/>
                <a:gridCol w="609600"/>
                <a:gridCol w="685800"/>
                <a:gridCol w="914400"/>
                <a:gridCol w="838200"/>
                <a:gridCol w="685800"/>
                <a:gridCol w="914400"/>
                <a:gridCol w="457200"/>
              </a:tblGrid>
              <a:tr h="144251">
                <a:tc gridSpan="10"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kern="1200" dirty="0" smtClean="0">
                          <a:solidFill>
                            <a:schemeClr val="bg1"/>
                          </a:solidFill>
                          <a:latin typeface="+mn-lt"/>
                          <a:ea typeface="+mn-ea"/>
                          <a:cs typeface="+mn-cs"/>
                        </a:rPr>
                        <a:t>Supplementary Table 2</a:t>
                      </a:r>
                      <a:endParaRPr lang="en-GB" sz="1000" b="1" kern="1200" dirty="0" smtClean="0">
                        <a:solidFill>
                          <a:schemeClr val="bg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85" marR="3985" marT="39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 gridSpan="10"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Rating of CME activities by their contribution to physician’s efforts for medical education on ongoing basis </a:t>
                      </a:r>
                      <a:r>
                        <a:rPr lang="en-US" sz="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lang="en-US" sz="10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n=746)</a:t>
                      </a:r>
                      <a:endParaRPr lang="en-GB" sz="1100" kern="12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85" marR="3985" marT="398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Rat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Medical </a:t>
                      </a:r>
                      <a:r>
                        <a:rPr lang="en-US" sz="1000" b="1" u="none" strike="noStrike" dirty="0" smtClean="0">
                          <a:effectLst/>
                          <a:latin typeface="+mj-lt"/>
                        </a:rPr>
                        <a:t> oncolog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Psychiatr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 err="1">
                          <a:effectLst/>
                          <a:latin typeface="+mj-lt"/>
                        </a:rPr>
                        <a:t>Diabetolog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Rheumatolog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Dermatolog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 smtClean="0">
                          <a:effectLst/>
                          <a:latin typeface="+mj-lt"/>
                        </a:rPr>
                        <a:t>Orthopedic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 err="1">
                          <a:effectLst/>
                          <a:latin typeface="+mj-lt"/>
                        </a:rPr>
                        <a:t>Neurophysicia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GP/F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79696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effectLst/>
                          <a:latin typeface="+mj-lt"/>
                        </a:rPr>
                        <a:t>Journals, Full Text 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Lea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6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79696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Neutr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31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Most effectiv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62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Reference </a:t>
                      </a:r>
                      <a:r>
                        <a:rPr lang="en-US" sz="1000" b="1" u="none" strike="noStrike" dirty="0" smtClean="0">
                          <a:effectLst/>
                          <a:latin typeface="+mj-lt"/>
                        </a:rPr>
                        <a:t>Books/</a:t>
                      </a:r>
                      <a:r>
                        <a:rPr lang="en-US" sz="1000" b="1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oduct Monographs</a:t>
                      </a:r>
                      <a:endParaRPr lang="en-US" sz="1000" b="1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Lea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214384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Neutr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30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Mo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52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Virtual </a:t>
                      </a:r>
                      <a:r>
                        <a:rPr lang="en-US" sz="1000" b="1" u="none" strike="noStrike" dirty="0" smtClean="0">
                          <a:effectLst/>
                          <a:latin typeface="+mj-lt"/>
                        </a:rPr>
                        <a:t>Lectures/</a:t>
                      </a:r>
                      <a:r>
                        <a:rPr lang="en-US" sz="1000" b="1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ebcasts</a:t>
                      </a:r>
                      <a:endParaRPr lang="en-US" sz="1000" b="1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Lea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79696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Neutr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42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Mo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214384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j-lt"/>
                        </a:rPr>
                        <a:t>Industrial </a:t>
                      </a:r>
                      <a:r>
                        <a:rPr lang="en-US" sz="1000" b="1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pport/Facilitatio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Lea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8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29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Neutr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Mo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effectLst/>
                          <a:latin typeface="+mj-lt"/>
                        </a:rPr>
                        <a:t>CDs, DVD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Least effectiv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79696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Neutr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34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Mo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53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effectLst/>
                          <a:latin typeface="+mj-lt"/>
                        </a:rPr>
                        <a:t>Website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Lea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13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79696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Neutr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Mo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56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20968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Live Speaker Programs/Workshop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Lea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6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79696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Neutr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Mo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2143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Round Table </a:t>
                      </a:r>
                      <a:r>
                        <a:rPr lang="en-US" sz="1000" b="1" u="none" strike="noStrike" dirty="0" smtClean="0">
                          <a:effectLst/>
                          <a:latin typeface="+mj-lt"/>
                        </a:rPr>
                        <a:t>Meeting/focused group meeting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Lea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9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79696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Neutr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Mo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72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effectLst/>
                          <a:latin typeface="+mj-lt"/>
                        </a:rPr>
                        <a:t>Conference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Lea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12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79696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Neutr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3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11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Mo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21438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+mj-lt"/>
                        </a:rPr>
                        <a:t>Case Presentation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Lea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5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79696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Neutr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23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31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18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1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2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19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  <a:tr h="14425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Most effec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8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7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  <a:latin typeface="+mj-lt"/>
                        </a:rPr>
                        <a:t>6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  <a:latin typeface="+mj-lt"/>
                        </a:rPr>
                        <a:t>70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3985" marR="3985" marT="398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111697395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ontent Placeholder 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4193951273"/>
              </p:ext>
            </p:extLst>
          </p:nvPr>
        </p:nvGraphicFramePr>
        <p:xfrm>
          <a:off x="152400" y="228600"/>
          <a:ext cx="8766710" cy="6294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5400"/>
                <a:gridCol w="1093406"/>
                <a:gridCol w="723277"/>
                <a:gridCol w="859970"/>
                <a:gridCol w="977089"/>
                <a:gridCol w="859970"/>
                <a:gridCol w="909073"/>
                <a:gridCol w="1048420"/>
                <a:gridCol w="1000105"/>
              </a:tblGrid>
              <a:tr h="381000">
                <a:tc gridSpan="9"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+mn-lt"/>
                        </a:rPr>
                        <a:t>Supplementary Table </a:t>
                      </a:r>
                      <a:r>
                        <a:rPr kumimoji="0" lang="en-US" sz="12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3</a:t>
                      </a:r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533400">
                <a:tc gridSpan="9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(a) T</a:t>
                      </a:r>
                      <a:r>
                        <a:rPr kumimoji="0" lang="en-US" sz="1200" b="1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ime</a:t>
                      </a:r>
                      <a:r>
                        <a:rPr kumimoji="0" lang="en-US" sz="12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 spent on all types of medical education activities per month (n=746)</a:t>
                      </a:r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457200"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edical Onc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Psychiatr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iabe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Rheu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er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Orthopaedics</a:t>
                      </a:r>
                      <a:endParaRPr kumimoji="0" lang="en-GB" sz="1200" b="1" i="0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europhysicia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en-GB" sz="1200" b="1" i="0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GP/FP</a:t>
                      </a:r>
                      <a:endParaRPr kumimoji="0" lang="en-GB" sz="1200" b="1" i="0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Barely find time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1–5 </a:t>
                      </a:r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Hour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6–10 </a:t>
                      </a:r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Hour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11–15 </a:t>
                      </a:r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Hour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16+ Hour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Mean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.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.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.6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.5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.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.5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.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 gridSpan="9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200" b="1" i="0" u="none" strike="noStrike" kern="1200" cap="none" spc="0" normalizeH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Arial" pitchFamily="34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1" i="0" u="none" strike="noStrike" kern="1200" cap="none" spc="0" normalizeH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(b) Satisfaction with </a:t>
                      </a:r>
                      <a:r>
                        <a:rPr kumimoji="0" lang="en-US" sz="12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the time spent on medical education activities (n=746)</a:t>
                      </a:r>
                    </a:p>
                    <a:p>
                      <a:pPr algn="l" fontAlgn="ctr"/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   Ye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   No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3875">
                <a:tc gridSpan="9">
                  <a:txBody>
                    <a:bodyPr/>
                    <a:lstStyle/>
                    <a:p>
                      <a:pPr lvl="0" algn="ctr" fontAlgn="auto">
                        <a:spcAft>
                          <a:spcPts val="0"/>
                        </a:spcAft>
                        <a:defRPr/>
                      </a:pPr>
                      <a:endParaRPr lang="en-US" sz="1200" b="1" kern="12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lvl="0" algn="ctr" fontAlgn="auto">
                        <a:spcAft>
                          <a:spcPts val="0"/>
                        </a:spcAft>
                        <a:defRPr/>
                      </a:pP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c) T</a:t>
                      </a:r>
                      <a:r>
                        <a:rPr kumimoji="0" lang="en-US" sz="1200" b="1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ime</a:t>
                      </a:r>
                      <a:r>
                        <a:rPr kumimoji="0" lang="en-US" sz="12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 spent on the internet for medical education per week </a:t>
                      </a:r>
                      <a:r>
                        <a:rPr kumimoji="0" lang="en-US" sz="12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(n=746)</a:t>
                      </a:r>
                      <a:endPara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Barely find time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1–5 </a:t>
                      </a:r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Hour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6–10 </a:t>
                      </a:r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Hour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11–15 </a:t>
                      </a:r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Hour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16+ Hour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0</a:t>
                      </a:r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Mean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.3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.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.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.3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.6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.4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.4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.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987966299"/>
              </p:ext>
            </p:extLst>
          </p:nvPr>
        </p:nvGraphicFramePr>
        <p:xfrm>
          <a:off x="76200" y="152400"/>
          <a:ext cx="8985886" cy="64649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49643"/>
                <a:gridCol w="1084390"/>
                <a:gridCol w="731520"/>
                <a:gridCol w="731520"/>
                <a:gridCol w="914400"/>
                <a:gridCol w="976630"/>
                <a:gridCol w="914400"/>
                <a:gridCol w="914400"/>
                <a:gridCol w="1037463"/>
                <a:gridCol w="731520"/>
              </a:tblGrid>
              <a:tr h="457200">
                <a:tc gridSpan="10"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ysClr val="windowText" lastClr="000000"/>
                          </a:solidFill>
                          <a:cs typeface="Arial" pitchFamily="34" charset="0"/>
                        </a:rPr>
                        <a:t>Supplementary Table 4</a:t>
                      </a:r>
                      <a:endParaRPr lang="en-GB" sz="1200" dirty="0">
                        <a:solidFill>
                          <a:schemeClr val="bg1"/>
                        </a:solidFill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57200">
                <a:tc gridSpan="10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ysClr val="windowText" lastClr="000000"/>
                          </a:solidFill>
                          <a:cs typeface="Arial" pitchFamily="34" charset="0"/>
                        </a:rPr>
                        <a:t>Preferred duration for CME activities</a:t>
                      </a:r>
                      <a:endParaRPr lang="en-GB" sz="1200" dirty="0">
                        <a:solidFill>
                          <a:schemeClr val="bg1"/>
                        </a:solidFill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200" dirty="0">
                        <a:solidFill>
                          <a:schemeClr val="bg1"/>
                        </a:solidFill>
                        <a:latin typeface="+mj-lt"/>
                      </a:endParaRPr>
                    </a:p>
                  </a:txBody>
                  <a:tcPr marL="45720" marR="4572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/>
                </a:tc>
              </a:tr>
              <a:tr h="457200">
                <a:tc>
                  <a:txBody>
                    <a:bodyPr/>
                    <a:lstStyle/>
                    <a:p>
                      <a:endParaRPr lang="en-GB" sz="1200" dirty="0">
                        <a:solidFill>
                          <a:schemeClr val="bg1"/>
                        </a:solidFill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+mj-lt"/>
                        </a:rPr>
                        <a:t>Rate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latin typeface="+mj-lt"/>
                        </a:rPr>
                        <a:t>Medical </a:t>
                      </a:r>
                      <a:endParaRPr lang="en-GB" sz="1200" b="1" i="0" u="none" strike="noStrike" dirty="0" smtClean="0">
                        <a:latin typeface="+mj-lt"/>
                      </a:endParaRPr>
                    </a:p>
                    <a:p>
                      <a:pPr algn="ctr" fontAlgn="b"/>
                      <a:r>
                        <a:rPr lang="en-GB" sz="1200" b="1" i="0" u="none" strike="noStrike" dirty="0" smtClean="0">
                          <a:latin typeface="+mj-lt"/>
                        </a:rPr>
                        <a:t>Oncology</a:t>
                      </a:r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latin typeface="+mj-lt"/>
                        </a:rPr>
                        <a:t>Psychiatr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 err="1">
                          <a:latin typeface="+mj-lt"/>
                        </a:rPr>
                        <a:t>Diabetology</a:t>
                      </a:r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latin typeface="+mj-lt"/>
                        </a:rPr>
                        <a:t>Rheu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latin typeface="+mj-lt"/>
                        </a:rPr>
                        <a:t>Der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 smtClean="0">
                          <a:latin typeface="+mj-lt"/>
                        </a:rPr>
                        <a:t>Orthopaedics</a:t>
                      </a:r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 smtClean="0">
                          <a:latin typeface="+mj-lt"/>
                        </a:rPr>
                        <a:t>Neurophysician</a:t>
                      </a:r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 smtClean="0">
                          <a:latin typeface="+mj-lt"/>
                        </a:rPr>
                        <a:t>GP/FP</a:t>
                      </a:r>
                      <a:endParaRPr lang="en-GB" sz="1200" b="1" i="0" u="none" strike="noStrike" dirty="0"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734">
                <a:tc rowSpan="5"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Webcast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+mj-lt"/>
                        </a:rPr>
                        <a:t>Up to 1 hour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6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7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1–2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2–4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4–8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8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dirty="0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rowSpan="5"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KOL Lectur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+mj-lt"/>
                        </a:rPr>
                        <a:t>Up–1 hour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4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1–2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2–4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4–8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8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03734">
                <a:tc rowSpan="5"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Hands-on </a:t>
                      </a:r>
                    </a:p>
                    <a:p>
                      <a:pPr algn="l" rtl="0" fontAlgn="b"/>
                      <a:r>
                        <a:rPr lang="en-GB" sz="1200" b="1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Workshop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+mj-lt"/>
                        </a:rPr>
                        <a:t>Up to 1 hour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1–2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2–4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4–8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1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8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rowSpan="5"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Round Table </a:t>
                      </a:r>
                    </a:p>
                    <a:p>
                      <a:pPr algn="l" rtl="0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Meeting/ </a:t>
                      </a:r>
                    </a:p>
                    <a:p>
                      <a:pPr algn="l" rtl="0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Focused </a:t>
                      </a:r>
                    </a:p>
                    <a:p>
                      <a:pPr algn="l" rtl="0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Group Meetin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+mj-lt"/>
                        </a:rPr>
                        <a:t>Up</a:t>
                      </a:r>
                      <a:r>
                        <a:rPr lang="en-US" sz="1200" b="1" baseline="0" dirty="0" smtClean="0">
                          <a:latin typeface="+mj-lt"/>
                        </a:rPr>
                        <a:t> to </a:t>
                      </a:r>
                      <a:r>
                        <a:rPr lang="en-US" sz="1200" b="1" dirty="0" smtClean="0">
                          <a:latin typeface="+mj-lt"/>
                        </a:rPr>
                        <a:t>1 hour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1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1–2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3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2–4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4–8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8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BF5"/>
                    </a:solidFill>
                  </a:tcPr>
                </a:tc>
              </a:tr>
              <a:tr h="203734">
                <a:tc rowSpan="5"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Case </a:t>
                      </a:r>
                    </a:p>
                    <a:p>
                      <a:pPr algn="l" rtl="0" fontAlgn="b"/>
                      <a:r>
                        <a:rPr lang="en-GB" sz="1200" b="1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Presentation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+mj-lt"/>
                        </a:rPr>
                        <a:t>Up to 1 hour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4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5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1–2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2–4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4–8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  <a:tr h="203734"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>
                          <a:latin typeface="+mj-lt"/>
                        </a:rPr>
                        <a:t>&gt;8 hours</a:t>
                      </a:r>
                      <a:endParaRPr lang="en-GB" sz="1200" b="1" dirty="0">
                        <a:latin typeface="+mj-lt"/>
                      </a:endParaRPr>
                    </a:p>
                  </a:txBody>
                  <a:tcPr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5EA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ontent Placeholder 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718515528"/>
              </p:ext>
            </p:extLst>
          </p:nvPr>
        </p:nvGraphicFramePr>
        <p:xfrm>
          <a:off x="148690" y="451485"/>
          <a:ext cx="8766710" cy="332041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92537"/>
                <a:gridCol w="796269"/>
                <a:gridCol w="723277"/>
                <a:gridCol w="859970"/>
                <a:gridCol w="977089"/>
                <a:gridCol w="859970"/>
                <a:gridCol w="909073"/>
                <a:gridCol w="1048420"/>
                <a:gridCol w="1000105"/>
              </a:tblGrid>
              <a:tr h="457200">
                <a:tc gridSpan="9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Supplementary Table 5a</a:t>
                      </a:r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57200">
                <a:tc gridSpan="9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(a) Most important factors for the non-attendance 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in a </a:t>
                      </a:r>
                      <a:r>
                        <a:rPr kumimoji="0" lang="en-US" sz="12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CME activity</a:t>
                      </a:r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457200"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edical Onc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Psychiatr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iabe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Rheu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er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Orthopaedics</a:t>
                      </a:r>
                      <a:endParaRPr kumimoji="0" lang="en-GB" sz="1200" b="1" i="0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europhysicia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en-GB" sz="1200" b="1" i="0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GP/FP</a:t>
                      </a:r>
                      <a:endParaRPr kumimoji="0" lang="en-GB" sz="1200" b="1" i="0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Quality/Relevance of Scientific Programs</a:t>
                      </a:r>
                      <a:endParaRPr kumimoji="0" lang="en-GB" sz="1200" b="1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eeting is too </a:t>
                      </a:r>
                      <a:r>
                        <a:rPr kumimoji="0" lang="en-GB" sz="1200" b="1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Expensive</a:t>
                      </a:r>
                      <a:endParaRPr kumimoji="0" lang="en-GB" sz="1200" b="1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Work </a:t>
                      </a:r>
                      <a:r>
                        <a:rPr kumimoji="0" lang="en-GB" sz="1200" b="1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Schedule Conflicts</a:t>
                      </a:r>
                      <a:endParaRPr kumimoji="0" lang="en-GB" sz="1200" b="1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US" sz="1200" b="1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Too </a:t>
                      </a:r>
                      <a:r>
                        <a:rPr kumimoji="0" lang="en-US" sz="1200" b="1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Short of a Notice Period</a:t>
                      </a:r>
                      <a:endParaRPr kumimoji="0" lang="en-US" sz="1200" b="1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Personal commitmen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Previous bad experienc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ontent Placeholder 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718515528"/>
              </p:ext>
            </p:extLst>
          </p:nvPr>
        </p:nvGraphicFramePr>
        <p:xfrm>
          <a:off x="148690" y="451485"/>
          <a:ext cx="8766710" cy="27813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92537"/>
                <a:gridCol w="796269"/>
                <a:gridCol w="723277"/>
                <a:gridCol w="859970"/>
                <a:gridCol w="977089"/>
                <a:gridCol w="859970"/>
                <a:gridCol w="909073"/>
                <a:gridCol w="1048420"/>
                <a:gridCol w="1000105"/>
              </a:tblGrid>
              <a:tr h="457200">
                <a:tc gridSpan="9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Supplementary Table 5b</a:t>
                      </a:r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74320">
                <a:tc gridSpan="9">
                  <a:txBody>
                    <a:bodyPr/>
                    <a:lstStyle/>
                    <a:p>
                      <a:pPr marL="0" algn="ctr" rtl="0" eaLnBrk="1" fontAlgn="ctr" latinLnBrk="0" hangingPunct="1"/>
                      <a:r>
                        <a:rPr kumimoji="0" lang="en-GB" sz="1200" b="1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(b) </a:t>
                      </a:r>
                      <a:r>
                        <a:rPr kumimoji="0" lang="en-US" sz="12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Most important aspect of CME activity </a:t>
                      </a:r>
                      <a:endParaRPr kumimoji="0" lang="en-GB" sz="1200" b="1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200" b="0" i="0" u="none" strike="noStrike" dirty="0"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Location/Venue</a:t>
                      </a:r>
                      <a:endParaRPr kumimoji="0" lang="en-GB" sz="1200" b="1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istance/Convenience to Travel</a:t>
                      </a:r>
                      <a:endParaRPr kumimoji="0" lang="en-GB" sz="1200" b="1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Travel </a:t>
                      </a:r>
                      <a:r>
                        <a:rPr kumimoji="0" lang="en-GB" sz="1200" b="1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and Stay Arrangements</a:t>
                      </a:r>
                      <a:endParaRPr kumimoji="0" lang="en-GB" sz="1200" b="1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uration/Dates</a:t>
                      </a:r>
                      <a:endParaRPr kumimoji="0" lang="en-GB" sz="1200" b="1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Reputation of the Spons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algn="l" rtl="0" eaLnBrk="1" fontAlgn="ctr" latinLnBrk="0" hangingPunct="1"/>
                      <a:r>
                        <a:rPr kumimoji="0" lang="en-GB" sz="1200" b="1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Co-participants/Peer Group</a:t>
                      </a:r>
                      <a:endParaRPr kumimoji="0" lang="en-GB" sz="1200" b="1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670787109"/>
              </p:ext>
            </p:extLst>
          </p:nvPr>
        </p:nvGraphicFramePr>
        <p:xfrm>
          <a:off x="76197" y="1201738"/>
          <a:ext cx="8991602" cy="30670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52603"/>
                <a:gridCol w="990600"/>
                <a:gridCol w="685800"/>
                <a:gridCol w="685800"/>
                <a:gridCol w="762000"/>
                <a:gridCol w="914400"/>
                <a:gridCol w="838200"/>
                <a:gridCol w="884759"/>
                <a:gridCol w="944041"/>
                <a:gridCol w="533399"/>
              </a:tblGrid>
              <a:tr h="200025">
                <a:tc gridSpan="10">
                  <a:txBody>
                    <a:bodyPr/>
                    <a:lstStyle/>
                    <a:p>
                      <a:pPr algn="ctr" rtl="0" fontAlgn="ctr"/>
                      <a:r>
                        <a:rPr lang="en-US" sz="1200" b="1" u="none" strike="noStrike" dirty="0">
                          <a:effectLst/>
                        </a:rPr>
                        <a:t>Supplementary </a:t>
                      </a:r>
                      <a:r>
                        <a:rPr lang="en-US" sz="1200" b="1" u="none" strike="noStrike" dirty="0" smtClean="0">
                          <a:effectLst/>
                        </a:rPr>
                        <a:t>Table 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200025">
                <a:tc gridSpan="10"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Rating of the quality characteristics of various CME </a:t>
                      </a:r>
                      <a:r>
                        <a:rPr lang="en-US" sz="1200" b="1" u="none" strike="noStrike" dirty="0" smtClean="0">
                          <a:effectLst/>
                        </a:rPr>
                        <a:t>activitie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Rating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Medical 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Psychiatry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Diabetology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Rheumatology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ermatology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err="1">
                          <a:effectLst/>
                        </a:rPr>
                        <a:t>Orthopaedic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err="1">
                          <a:effectLst/>
                        </a:rPr>
                        <a:t>Neurophysicia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GP/FP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Oncology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tature of </a:t>
                      </a:r>
                      <a:r>
                        <a:rPr lang="en-US" sz="1100" u="none" strike="noStrike" dirty="0" smtClean="0">
                          <a:effectLst/>
                        </a:rPr>
                        <a:t>Speakers/Author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Least effectiv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eutr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7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20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7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1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1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st effec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8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cientific </a:t>
                      </a:r>
                      <a:r>
                        <a:rPr lang="en-US" sz="1100" u="none" strike="noStrike" dirty="0" smtClean="0">
                          <a:effectLst/>
                        </a:rPr>
                        <a:t>Agend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Least effec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eutr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st effec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1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cope for </a:t>
                      </a:r>
                      <a:r>
                        <a:rPr lang="en-US" sz="1100" u="none" strike="noStrike" dirty="0" smtClean="0">
                          <a:effectLst/>
                        </a:rPr>
                        <a:t>Active Participa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Least effec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eutr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1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st effec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3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1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1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ponso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Least effec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3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7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8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1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8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eutr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8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8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8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st effec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7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3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42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1377259263"/>
      </p:ext>
    </p:extLst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ontent Placeholder 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705609745"/>
              </p:ext>
            </p:extLst>
          </p:nvPr>
        </p:nvGraphicFramePr>
        <p:xfrm>
          <a:off x="152400" y="762000"/>
          <a:ext cx="8766710" cy="5105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92537"/>
                <a:gridCol w="796269"/>
                <a:gridCol w="723277"/>
                <a:gridCol w="859970"/>
                <a:gridCol w="977089"/>
                <a:gridCol w="859970"/>
                <a:gridCol w="909073"/>
                <a:gridCol w="1048420"/>
                <a:gridCol w="1000105"/>
              </a:tblGrid>
              <a:tr h="457200">
                <a:tc gridSpan="9"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  <a:cs typeface="Arial" pitchFamily="34" charset="0"/>
                        </a:rPr>
                        <a:t>Supplementary Table </a:t>
                      </a:r>
                      <a:r>
                        <a:rPr lang="en-US" sz="1200" b="1" dirty="0" smtClean="0">
                          <a:solidFill>
                            <a:schemeClr val="tx1"/>
                          </a:solidFill>
                          <a:cs typeface="Arial" pitchFamily="34" charset="0"/>
                        </a:rPr>
                        <a:t>7</a:t>
                      </a:r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57200">
                <a:tc gridSpan="9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chemeClr val="tx1"/>
                          </a:solidFill>
                          <a:cs typeface="Arial" pitchFamily="34" charset="0"/>
                        </a:rPr>
                        <a:t>Preferred areas for discussion for upcoming CME activities</a:t>
                      </a:r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457200"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edical Onc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Psychiatr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iabe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Rheu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er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Orthopaedics</a:t>
                      </a:r>
                      <a:endParaRPr kumimoji="0" lang="en-GB" sz="1200" b="1" i="0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europhysicia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en-GB" sz="1200" b="1" i="0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GP/FP</a:t>
                      </a:r>
                      <a:endParaRPr kumimoji="0" lang="en-GB" sz="1200" b="1" i="0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Disease Guidelines 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9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9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Administrative  and Management Skill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4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4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err="1" smtClean="0">
                          <a:solidFill>
                            <a:schemeClr val="tx1"/>
                          </a:solidFill>
                          <a:latin typeface="+mj-lt"/>
                        </a:rPr>
                        <a:t>Pharmacovigilance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6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Good Clinical Practice (GCP) Guideline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New Drugs/Devices/</a:t>
                      </a:r>
                    </a:p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Intervention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7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9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9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Ethics &amp; Medico-legal Aspect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8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7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7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7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7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9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Patient Counselling Skill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7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6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7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6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6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 dirty="0" err="1" smtClean="0">
                          <a:solidFill>
                            <a:schemeClr val="tx1"/>
                          </a:solidFill>
                          <a:latin typeface="+mj-lt"/>
                        </a:rPr>
                        <a:t>Pharmacoeconomics</a:t>
                      </a:r>
                      <a:r>
                        <a:rPr lang="en-GB" sz="1200" b="1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 &amp; Healthcare Decision Making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4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4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Publication/Medical Writing Skills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4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5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1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Holistic/Integrated Medicine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2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3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3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2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2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ontent Placeholder 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798845079"/>
              </p:ext>
            </p:extLst>
          </p:nvPr>
        </p:nvGraphicFramePr>
        <p:xfrm>
          <a:off x="228600" y="1905000"/>
          <a:ext cx="8766710" cy="2651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19200"/>
                <a:gridCol w="1169606"/>
                <a:gridCol w="723277"/>
                <a:gridCol w="859970"/>
                <a:gridCol w="977089"/>
                <a:gridCol w="859970"/>
                <a:gridCol w="909073"/>
                <a:gridCol w="1048420"/>
                <a:gridCol w="1000105"/>
              </a:tblGrid>
              <a:tr h="457200">
                <a:tc gridSpan="9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1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Supplementary Table </a:t>
                      </a:r>
                      <a:r>
                        <a:rPr kumimoji="0" lang="en-US" sz="1200" b="1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8</a:t>
                      </a:r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57200">
                <a:tc gridSpan="9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kern="12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Arial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I</a:t>
                      </a:r>
                      <a:r>
                        <a:rPr kumimoji="0" lang="en-US" sz="1200" b="1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nvitations</a:t>
                      </a:r>
                      <a:r>
                        <a:rPr kumimoji="0" lang="en-US" sz="1200" b="1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 received to attend certified 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continued </a:t>
                      </a:r>
                      <a:r>
                        <a:rPr kumimoji="0" lang="en-US" sz="1200" b="1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medical education courses 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Arial" pitchFamily="34" charset="0"/>
                        </a:rPr>
                        <a:t>per</a:t>
                      </a:r>
                      <a:r>
                        <a:rPr kumimoji="0" lang="en-US" sz="1200" b="1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Arial" pitchFamily="34" charset="0"/>
                        </a:rPr>
                        <a:t> year (n=723)</a:t>
                      </a:r>
                    </a:p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marL="0" algn="ctr" rtl="0" eaLnBrk="1" fontAlgn="b" latinLnBrk="0" hangingPunct="1"/>
                      <a:endParaRPr kumimoji="0" lang="en-GB" sz="1200" b="1" i="0" u="none" strike="noStrike" kern="1200" dirty="0">
                        <a:solidFill>
                          <a:schemeClr val="lt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</a:tr>
              <a:tr h="457200"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Medical Onc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Psychiatr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iabe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Rheu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Dermatolog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Orthopaedics</a:t>
                      </a:r>
                      <a:endParaRPr kumimoji="0" lang="en-GB" sz="1200" b="1" i="0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Neurophysicia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algn="ctr" rtl="0" eaLnBrk="1" fontAlgn="b" latinLnBrk="0" hangingPunct="1"/>
                      <a:r>
                        <a:rPr kumimoji="0" lang="en-GB" sz="1200" b="1" i="0" u="none" strike="noStrike" kern="1200" dirty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en-GB" sz="1200" b="1" i="0" u="none" strike="noStrike" kern="1200" dirty="0" smtClean="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GP/FP</a:t>
                      </a:r>
                      <a:endParaRPr kumimoji="0" lang="en-GB" sz="1200" b="1" i="0" u="none" strike="noStrike" kern="1200" dirty="0">
                        <a:solidFill>
                          <a:schemeClr val="tx1"/>
                        </a:solidFill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Barely </a:t>
                      </a:r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any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0</a:t>
                      </a:r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1–3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4–9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4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GB" sz="1200" b="1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10 and more</a:t>
                      </a:r>
                      <a:endParaRPr lang="en-GB" sz="1200" b="1" i="0" u="none" strike="noStrike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3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2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Theme1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109</TotalTime>
  <Words>2460</Words>
  <Application>Microsoft Office PowerPoint</Application>
  <PresentationFormat>On-screen Show (4:3)</PresentationFormat>
  <Paragraphs>1213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Theme1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Template</dc:title>
  <dc:creator>Rajesh</dc:creator>
  <cp:lastModifiedBy>Hanumanth Reddy</cp:lastModifiedBy>
  <cp:revision>2170</cp:revision>
  <dcterms:created xsi:type="dcterms:W3CDTF">2010-09-21T05:24:34Z</dcterms:created>
  <dcterms:modified xsi:type="dcterms:W3CDTF">2016-01-04T11:11:03Z</dcterms:modified>
</cp:coreProperties>
</file>